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116638" cy="86407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nl-NL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14720" y="685440"/>
            <a:ext cx="2428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nl-NL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274CAB7-4ACB-483E-BDC5-8A1D9636C6BC}" type="slidenum">
              <a:rPr b="0" lang="nl-NL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sldImg"/>
          </p:nvPr>
        </p:nvSpPr>
        <p:spPr>
          <a:xfrm>
            <a:off x="2214720" y="685800"/>
            <a:ext cx="2428560" cy="3429000"/>
          </a:xfrm>
          <a:prstGeom prst="rect">
            <a:avLst/>
          </a:prstGeom>
          <a:ln w="0">
            <a:noFill/>
          </a:ln>
        </p:spPr>
      </p:sp>
      <p:sp>
        <p:nvSpPr>
          <p:cNvPr id="5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nl-NL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CD028A7-4840-4383-AF11-A8F36F1B4AE4}" type="slidenum">
              <a:rPr b="0" lang="nl-NL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AEB3B1-B10C-4809-A49B-89FCC83E8C5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550404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000" y="4994640"/>
            <a:ext cx="550404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52B30-A3A3-4D90-9710-553E074298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6600" y="201600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000" y="499464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6600" y="499464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AB080-F601-4139-8B2F-65A0599247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1771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6840" y="2016000"/>
            <a:ext cx="1771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27680" y="2016000"/>
            <a:ext cx="1771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000" y="4994640"/>
            <a:ext cx="1771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6840" y="4994640"/>
            <a:ext cx="1771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27680" y="4994640"/>
            <a:ext cx="177192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922E5-BE6C-4452-A97A-B29E59F7D1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000" y="2016000"/>
            <a:ext cx="5504040" cy="5702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97D5D0-0FF1-495F-BB5B-ACA0332FA0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550404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9F618C-35CD-4B80-8EFC-775AF55B73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268596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6600" y="2016000"/>
            <a:ext cx="268596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D1DCF2-ACFA-4B98-B4E7-CA2AD9F292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3449B-A501-4A75-B342-9B90AB6EB0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000" y="345960"/>
            <a:ext cx="5504040" cy="66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6AFF1D-13F5-4C94-AC8C-C5775969C38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6600" y="2016000"/>
            <a:ext cx="268596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000" y="499464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557AF-8AEE-4853-B3AD-555D724262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268596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6600" y="201600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6600" y="499464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11FFC-E84D-4422-B3EC-01B5BB2F19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000" y="201600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6600" y="2016000"/>
            <a:ext cx="268596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000" y="4994640"/>
            <a:ext cx="5504040" cy="2719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A5CCFB-3B48-4B88-BE7F-842A36B6F1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000" y="345960"/>
            <a:ext cx="5504040" cy="1440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000" y="2016000"/>
            <a:ext cx="5504040" cy="5702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6360" y="8008560"/>
            <a:ext cx="142704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89080" y="8008560"/>
            <a:ext cx="193824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2640" y="8008560"/>
            <a:ext cx="1427400" cy="46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422A462-FE5C-4614-8060-C534B8EAD0F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Straight Connector 2"/>
          <p:cNvSpPr/>
          <p:nvPr/>
        </p:nvSpPr>
        <p:spPr>
          <a:xfrm>
            <a:off x="0" y="0"/>
            <a:ext cx="914400" cy="0"/>
          </a:xfrm>
          <a:prstGeom prst="line">
            <a:avLst/>
          </a:prstGeom>
          <a:ln w="0">
            <a:solidFill>
              <a:srgbClr val="fb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hthoek 5"/>
          <p:cNvSpPr/>
          <p:nvPr/>
        </p:nvSpPr>
        <p:spPr>
          <a:xfrm>
            <a:off x="831960" y="1031040"/>
            <a:ext cx="1620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ssessed for eligibil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18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hthoek 6"/>
          <p:cNvSpPr/>
          <p:nvPr/>
        </p:nvSpPr>
        <p:spPr>
          <a:xfrm>
            <a:off x="831960" y="2291400"/>
            <a:ext cx="1620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ligibl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179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hthoek 7"/>
          <p:cNvSpPr/>
          <p:nvPr/>
        </p:nvSpPr>
        <p:spPr>
          <a:xfrm>
            <a:off x="831960" y="3862080"/>
            <a:ext cx="162072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Questionnaires complete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hthoek 9"/>
          <p:cNvSpPr/>
          <p:nvPr/>
        </p:nvSpPr>
        <p:spPr>
          <a:xfrm>
            <a:off x="2570040" y="1432080"/>
            <a:ext cx="2948040" cy="855360"/>
          </a:xfrm>
          <a:prstGeom prst="rect">
            <a:avLst/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xcluded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emporary/PRN medicines only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rescribed by gynaecologist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ge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hthoek 10"/>
          <p:cNvSpPr/>
          <p:nvPr/>
        </p:nvSpPr>
        <p:spPr>
          <a:xfrm>
            <a:off x="2570040" y="2695680"/>
            <a:ext cx="2948040" cy="1159920"/>
          </a:xfrm>
          <a:prstGeom prst="rect">
            <a:avLst/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Questionnaire not completed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8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Unable to contact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5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atient not interested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1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lready contacted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Deceased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Other 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 = 1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Straight Arrow Connector 39"/>
          <p:cNvCxnSpPr>
            <a:stCxn id="49" idx="2"/>
            <a:endCxn id="50" idx="0"/>
          </p:cNvCxnSpPr>
          <p:nvPr/>
        </p:nvCxnSpPr>
        <p:spPr>
          <a:xfrm>
            <a:off x="1642320" y="1429560"/>
            <a:ext cx="360" cy="8622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sm"/>
          </a:ln>
        </p:spPr>
      </p:cxnSp>
      <p:cxnSp>
        <p:nvCxnSpPr>
          <p:cNvPr id="55" name="Straight Arrow Connector 44"/>
          <p:cNvCxnSpPr>
            <a:stCxn id="50" idx="2"/>
            <a:endCxn id="51" idx="0"/>
          </p:cNvCxnSpPr>
          <p:nvPr/>
        </p:nvCxnSpPr>
        <p:spPr>
          <a:xfrm>
            <a:off x="1642320" y="2689920"/>
            <a:ext cx="360" cy="11725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sm"/>
          </a:ln>
        </p:spPr>
      </p:cxnSp>
      <p:cxnSp>
        <p:nvCxnSpPr>
          <p:cNvPr id="56" name="Straight Arrow Connector 50"/>
          <p:cNvCxnSpPr/>
          <p:nvPr/>
        </p:nvCxnSpPr>
        <p:spPr>
          <a:xfrm flipH="1">
            <a:off x="1640880" y="1860120"/>
            <a:ext cx="9291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triangle" w="sm"/>
          </a:ln>
        </p:spPr>
      </p:cxnSp>
      <p:cxnSp>
        <p:nvCxnSpPr>
          <p:cNvPr id="57" name="Straight Arrow Connector 52"/>
          <p:cNvCxnSpPr/>
          <p:nvPr/>
        </p:nvCxnSpPr>
        <p:spPr>
          <a:xfrm flipH="1" flipV="1">
            <a:off x="1644120" y="3269520"/>
            <a:ext cx="9280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headEnd len="med" type="triangle" w="sm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5-13T13:33:50Z</dcterms:created>
  <dc:creator>Rik Ensing</dc:creator>
  <dc:description/>
  <dc:language>en-US</dc:language>
  <cp:lastModifiedBy>Ruby Janssen</cp:lastModifiedBy>
  <dcterms:modified xsi:type="dcterms:W3CDTF">2024-04-19T12:27:33Z</dcterms:modified>
  <cp:revision>24</cp:revision>
  <dc:subject/>
  <dc:title>PowerPoint Presentation</dc:title>
</cp:coreProperties>
</file>